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51"/>
    <p:restoredTop sz="94567" autoAdjust="0"/>
  </p:normalViewPr>
  <p:slideViewPr>
    <p:cSldViewPr snapToGrid="0" snapToObjects="1">
      <p:cViewPr>
        <p:scale>
          <a:sx n="150" d="100"/>
          <a:sy n="150" d="100"/>
        </p:scale>
        <p:origin x="760" y="144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nsen:Documents:&#30740;&#31350;:&#20491;&#20154;&#12501;&#12457;&#12523;&#12480;%20(Personal%20Folder):&#31070;&#23665;:&#35542;&#25991;:ZIKA-EAE:20200303%20zika,%20EAE%20(MR%20vs%20PRV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nsen:Documents:&#30740;&#31350;:&#20491;&#20154;&#12501;&#12457;&#12523;&#12480;%20(Personal%20Folder):&#31070;&#23665;:&#35542;&#25991;:ZIKA-EAE:20200303%20zika,%20EAE%20(MR%20vs%20PRV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375479171475112"/>
          <c:y val="0.0264227599989181"/>
          <c:w val="0.953369038179132"/>
          <c:h val="0.922059739763821"/>
        </c:manualLayout>
      </c:layout>
      <c:lineChart>
        <c:grouping val="standard"/>
        <c:varyColors val="0"/>
        <c:ser>
          <c:idx val="0"/>
          <c:order val="0"/>
          <c:tx>
            <c:strRef>
              <c:f>Sheet1!$A$85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Sheet1!$B$88:$W$88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816496580927726</c:v>
                  </c:pt>
                  <c:pt idx="11">
                    <c:v>0.816496580927726</c:v>
                  </c:pt>
                  <c:pt idx="12">
                    <c:v>1.211060141638997</c:v>
                  </c:pt>
                  <c:pt idx="13">
                    <c:v>1.329160135825126</c:v>
                  </c:pt>
                  <c:pt idx="14">
                    <c:v>1.471960144387975</c:v>
                  </c:pt>
                  <c:pt idx="15">
                    <c:v>1.211060141638997</c:v>
                  </c:pt>
                  <c:pt idx="16">
                    <c:v>1.032795558988645</c:v>
                  </c:pt>
                  <c:pt idx="17">
                    <c:v>0.516397779494323</c:v>
                  </c:pt>
                  <c:pt idx="18">
                    <c:v>0.516397779494323</c:v>
                  </c:pt>
                  <c:pt idx="19">
                    <c:v>0.516397779494323</c:v>
                  </c:pt>
                  <c:pt idx="20">
                    <c:v>0.752772652709081</c:v>
                  </c:pt>
                  <c:pt idx="21">
                    <c:v>0.752772652709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84:$W$84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85:$W$85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333333333333333</c:v>
                </c:pt>
                <c:pt idx="11">
                  <c:v>0.333333333333333</c:v>
                </c:pt>
                <c:pt idx="12">
                  <c:v>0.666666666666667</c:v>
                </c:pt>
                <c:pt idx="13">
                  <c:v>0.833333333333333</c:v>
                </c:pt>
                <c:pt idx="14">
                  <c:v>1.166666666666667</c:v>
                </c:pt>
                <c:pt idx="15">
                  <c:v>1.666666666666667</c:v>
                </c:pt>
                <c:pt idx="16">
                  <c:v>2.333333333333333</c:v>
                </c:pt>
                <c:pt idx="17">
                  <c:v>2.333333333333333</c:v>
                </c:pt>
                <c:pt idx="18">
                  <c:v>2.666666666666666</c:v>
                </c:pt>
                <c:pt idx="19">
                  <c:v>2.333333333333333</c:v>
                </c:pt>
                <c:pt idx="20">
                  <c:v>1.833333333333333</c:v>
                </c:pt>
                <c:pt idx="21">
                  <c:v>1.8333333333333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BBC-5D47-A855-F91ACDF10D83}"/>
            </c:ext>
          </c:extLst>
        </c:ser>
        <c:ser>
          <c:idx val="1"/>
          <c:order val="1"/>
          <c:tx>
            <c:strRef>
              <c:f>Sheet1!$A$86</c:f>
              <c:strCache>
                <c:ptCount val="1"/>
                <c:pt idx="0">
                  <c:v>MR</c:v>
                </c:pt>
              </c:strCache>
            </c:strRef>
          </c:tx>
          <c:spPr>
            <a:ln w="15875">
              <a:solidFill>
                <a:srgbClr val="FF0000"/>
              </a:solidFill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89:$W$89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547722557505166</c:v>
                  </c:pt>
                  <c:pt idx="11">
                    <c:v>0.836660026534076</c:v>
                  </c:pt>
                  <c:pt idx="12">
                    <c:v>1.032795558988645</c:v>
                  </c:pt>
                  <c:pt idx="13">
                    <c:v>1.211060141638996</c:v>
                  </c:pt>
                  <c:pt idx="14">
                    <c:v>0.836660026534076</c:v>
                  </c:pt>
                  <c:pt idx="15">
                    <c:v>0.983192080250175</c:v>
                  </c:pt>
                  <c:pt idx="16">
                    <c:v>0.983192080250175</c:v>
                  </c:pt>
                  <c:pt idx="17">
                    <c:v>0.0</c:v>
                  </c:pt>
                  <c:pt idx="18">
                    <c:v>0.816496580927725</c:v>
                  </c:pt>
                  <c:pt idx="19">
                    <c:v>0.816496580927725</c:v>
                  </c:pt>
                  <c:pt idx="20">
                    <c:v>0.816496580927725</c:v>
                  </c:pt>
                  <c:pt idx="21">
                    <c:v>0.752772652709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84:$W$84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86:$W$86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5</c:v>
                </c:pt>
                <c:pt idx="11">
                  <c:v>1.5</c:v>
                </c:pt>
                <c:pt idx="12">
                  <c:v>2.666666666666666</c:v>
                </c:pt>
                <c:pt idx="13">
                  <c:v>3.333333333333333</c:v>
                </c:pt>
                <c:pt idx="14">
                  <c:v>3.5</c:v>
                </c:pt>
                <c:pt idx="15">
                  <c:v>3.833333333333333</c:v>
                </c:pt>
                <c:pt idx="16">
                  <c:v>3.833333333333333</c:v>
                </c:pt>
                <c:pt idx="17">
                  <c:v>4.0</c:v>
                </c:pt>
                <c:pt idx="18">
                  <c:v>3.666666666666666</c:v>
                </c:pt>
                <c:pt idx="19">
                  <c:v>3.666666666666666</c:v>
                </c:pt>
                <c:pt idx="20">
                  <c:v>3.666666666666666</c:v>
                </c:pt>
                <c:pt idx="21">
                  <c:v>3.16666666666666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BBC-5D47-A855-F91ACDF10D83}"/>
            </c:ext>
          </c:extLst>
        </c:ser>
        <c:ser>
          <c:idx val="2"/>
          <c:order val="2"/>
          <c:tx>
            <c:strRef>
              <c:f>Sheet1!$A$87</c:f>
              <c:strCache>
                <c:ptCount val="1"/>
                <c:pt idx="0">
                  <c:v>PRV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squar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Sheet1!$B$90:$W$90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408248290463863</c:v>
                  </c:pt>
                  <c:pt idx="11">
                    <c:v>0.836660026534076</c:v>
                  </c:pt>
                  <c:pt idx="12">
                    <c:v>1.632993161855452</c:v>
                  </c:pt>
                  <c:pt idx="13">
                    <c:v>1.378404875209022</c:v>
                  </c:pt>
                  <c:pt idx="14">
                    <c:v>1.366260102127947</c:v>
                  </c:pt>
                  <c:pt idx="15">
                    <c:v>1.366260102127947</c:v>
                  </c:pt>
                  <c:pt idx="16">
                    <c:v>1.471960144387975</c:v>
                  </c:pt>
                  <c:pt idx="17">
                    <c:v>0.983192080250175</c:v>
                  </c:pt>
                  <c:pt idx="18">
                    <c:v>0.547722557505166</c:v>
                  </c:pt>
                  <c:pt idx="19">
                    <c:v>0.547722557505166</c:v>
                  </c:pt>
                  <c:pt idx="20">
                    <c:v>0.516397779494321</c:v>
                  </c:pt>
                  <c:pt idx="21">
                    <c:v>0.4082482904638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84:$W$84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87:$W$87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166666666666667</c:v>
                </c:pt>
                <c:pt idx="11">
                  <c:v>0.5</c:v>
                </c:pt>
                <c:pt idx="12">
                  <c:v>1.666666666666667</c:v>
                </c:pt>
                <c:pt idx="13">
                  <c:v>2.5</c:v>
                </c:pt>
                <c:pt idx="14">
                  <c:v>2.666666666666666</c:v>
                </c:pt>
                <c:pt idx="15">
                  <c:v>2.666666666666666</c:v>
                </c:pt>
                <c:pt idx="16">
                  <c:v>2.833333333333333</c:v>
                </c:pt>
                <c:pt idx="17">
                  <c:v>3.166666666666666</c:v>
                </c:pt>
                <c:pt idx="18">
                  <c:v>3.5</c:v>
                </c:pt>
                <c:pt idx="19">
                  <c:v>3.5</c:v>
                </c:pt>
                <c:pt idx="20">
                  <c:v>3.333333333333333</c:v>
                </c:pt>
                <c:pt idx="21">
                  <c:v>3.16666666666666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BBC-5D47-A855-F91ACDF10D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92828928"/>
        <c:axId val="-2064960816"/>
      </c:lineChart>
      <c:catAx>
        <c:axId val="-2092828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2064960816"/>
        <c:crosses val="autoZero"/>
        <c:auto val="1"/>
        <c:lblAlgn val="ctr"/>
        <c:lblOffset val="100"/>
        <c:tickLblSkip val="2"/>
        <c:tickMarkSkip val="2"/>
        <c:noMultiLvlLbl val="0"/>
      </c:catAx>
      <c:valAx>
        <c:axId val="-2064960816"/>
        <c:scaling>
          <c:orientation val="minMax"/>
          <c:max val="5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2092828928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161305546586"/>
          <c:y val="0.0485161480709916"/>
          <c:w val="0.876106833254676"/>
          <c:h val="0.742389818826948"/>
        </c:manualLayout>
      </c:layout>
      <c:lineChart>
        <c:grouping val="standard"/>
        <c:varyColors val="0"/>
        <c:ser>
          <c:idx val="0"/>
          <c:order val="0"/>
          <c:tx>
            <c:strRef>
              <c:f>Sheet1!$A$98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102:$W$102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2.068623060570345</c:v>
                  </c:pt>
                  <c:pt idx="2">
                    <c:v>2.283150818752905</c:v>
                  </c:pt>
                  <c:pt idx="3">
                    <c:v>2.169845955935183</c:v>
                  </c:pt>
                  <c:pt idx="4">
                    <c:v>2.208173850933554</c:v>
                  </c:pt>
                  <c:pt idx="5">
                    <c:v>2.961714227063591</c:v>
                  </c:pt>
                  <c:pt idx="6">
                    <c:v>2.77411444384564</c:v>
                  </c:pt>
                  <c:pt idx="7">
                    <c:v>2.779926578943675</c:v>
                  </c:pt>
                  <c:pt idx="8">
                    <c:v>4.125580718206461</c:v>
                  </c:pt>
                  <c:pt idx="9">
                    <c:v>4.48057816492887</c:v>
                  </c:pt>
                  <c:pt idx="10">
                    <c:v>6.941777774149955</c:v>
                  </c:pt>
                  <c:pt idx="11">
                    <c:v>8.728472667431641</c:v>
                  </c:pt>
                  <c:pt idx="12">
                    <c:v>9.990999132498568</c:v>
                  </c:pt>
                  <c:pt idx="13">
                    <c:v>7.619226872755655</c:v>
                  </c:pt>
                  <c:pt idx="14">
                    <c:v>11.60374180579664</c:v>
                  </c:pt>
                  <c:pt idx="15">
                    <c:v>8.649360202744988</c:v>
                  </c:pt>
                  <c:pt idx="16">
                    <c:v>8.943113710340539</c:v>
                  </c:pt>
                  <c:pt idx="17">
                    <c:v>7.21676731598806</c:v>
                  </c:pt>
                  <c:pt idx="18">
                    <c:v>4.359647463638206</c:v>
                  </c:pt>
                  <c:pt idx="19">
                    <c:v>3.917799493213077</c:v>
                  </c:pt>
                  <c:pt idx="20">
                    <c:v>4.94835377428073</c:v>
                  </c:pt>
                  <c:pt idx="21">
                    <c:v>5.979291337046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97:$W$97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98:$W$98</c:f>
              <c:numCache>
                <c:formatCode>General</c:formatCode>
                <c:ptCount val="22"/>
                <c:pt idx="0">
                  <c:v>100.0</c:v>
                </c:pt>
                <c:pt idx="1">
                  <c:v>103.0361267444674</c:v>
                </c:pt>
                <c:pt idx="2">
                  <c:v>104.540745467013</c:v>
                </c:pt>
                <c:pt idx="3">
                  <c:v>106.2144006038914</c:v>
                </c:pt>
                <c:pt idx="4">
                  <c:v>105.1952234220985</c:v>
                </c:pt>
                <c:pt idx="5">
                  <c:v>107.9905427694075</c:v>
                </c:pt>
                <c:pt idx="6">
                  <c:v>108.5005180387102</c:v>
                </c:pt>
                <c:pt idx="7">
                  <c:v>111.3426480907641</c:v>
                </c:pt>
                <c:pt idx="8">
                  <c:v>112.2681794198265</c:v>
                </c:pt>
                <c:pt idx="9">
                  <c:v>112.7928915409927</c:v>
                </c:pt>
                <c:pt idx="10">
                  <c:v>112.5776069997172</c:v>
                </c:pt>
                <c:pt idx="11">
                  <c:v>108.9532887401836</c:v>
                </c:pt>
                <c:pt idx="12">
                  <c:v>109.702431032216</c:v>
                </c:pt>
                <c:pt idx="13">
                  <c:v>110.5297704741028</c:v>
                </c:pt>
                <c:pt idx="14">
                  <c:v>106.9889338617551</c:v>
                </c:pt>
                <c:pt idx="15">
                  <c:v>106.5951161769492</c:v>
                </c:pt>
                <c:pt idx="16">
                  <c:v>106.0139063663066</c:v>
                </c:pt>
                <c:pt idx="17">
                  <c:v>106.2929419937002</c:v>
                </c:pt>
                <c:pt idx="18">
                  <c:v>102.9757006591415</c:v>
                </c:pt>
                <c:pt idx="19">
                  <c:v>107.2032989314718</c:v>
                </c:pt>
                <c:pt idx="20">
                  <c:v>107.9238083435155</c:v>
                </c:pt>
                <c:pt idx="21">
                  <c:v>107.528800349401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48F-5645-B240-C2C9EC0F38DB}"/>
            </c:ext>
          </c:extLst>
        </c:ser>
        <c:ser>
          <c:idx val="1"/>
          <c:order val="1"/>
          <c:tx>
            <c:strRef>
              <c:f>Sheet1!$A$99</c:f>
              <c:strCache>
                <c:ptCount val="1"/>
                <c:pt idx="0">
                  <c:v>MR</c:v>
                </c:pt>
              </c:strCache>
            </c:strRef>
          </c:tx>
          <c:spPr>
            <a:ln w="15875">
              <a:solidFill>
                <a:srgbClr val="FF0000"/>
              </a:solidFill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heet1!$B$103:$W$103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2.076342923969916</c:v>
                  </c:pt>
                  <c:pt idx="2">
                    <c:v>3.091370082831938</c:v>
                  </c:pt>
                  <c:pt idx="3">
                    <c:v>5.270690322841423</c:v>
                  </c:pt>
                  <c:pt idx="4">
                    <c:v>5.473744702661988</c:v>
                  </c:pt>
                  <c:pt idx="5">
                    <c:v>4.855368329305378</c:v>
                  </c:pt>
                  <c:pt idx="6">
                    <c:v>4.955602243599206</c:v>
                  </c:pt>
                  <c:pt idx="7">
                    <c:v>6.02124714027184</c:v>
                  </c:pt>
                  <c:pt idx="8">
                    <c:v>6.464598719885108</c:v>
                  </c:pt>
                  <c:pt idx="9">
                    <c:v>6.591346566750468</c:v>
                  </c:pt>
                  <c:pt idx="10">
                    <c:v>7.34620245451312</c:v>
                  </c:pt>
                  <c:pt idx="11">
                    <c:v>10.23746686343647</c:v>
                  </c:pt>
                  <c:pt idx="12">
                    <c:v>8.958216395255133</c:v>
                  </c:pt>
                  <c:pt idx="13">
                    <c:v>7.15932869657448</c:v>
                  </c:pt>
                  <c:pt idx="14">
                    <c:v>7.604028705306105</c:v>
                  </c:pt>
                  <c:pt idx="15">
                    <c:v>9.703489422427502</c:v>
                  </c:pt>
                  <c:pt idx="16">
                    <c:v>4.118453524533229</c:v>
                  </c:pt>
                  <c:pt idx="17">
                    <c:v>3.796621188156007</c:v>
                  </c:pt>
                  <c:pt idx="18">
                    <c:v>3.976578232546934</c:v>
                  </c:pt>
                  <c:pt idx="19">
                    <c:v>4.352684978695175</c:v>
                  </c:pt>
                  <c:pt idx="20">
                    <c:v>4.43663710160936</c:v>
                  </c:pt>
                  <c:pt idx="21">
                    <c:v>4.866383431084833</c:v>
                  </c:pt>
                </c:numCache>
              </c:numRef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97:$W$97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99:$W$99</c:f>
              <c:numCache>
                <c:formatCode>General</c:formatCode>
                <c:ptCount val="22"/>
                <c:pt idx="0">
                  <c:v>100.0</c:v>
                </c:pt>
                <c:pt idx="1">
                  <c:v>101.2092829812854</c:v>
                </c:pt>
                <c:pt idx="2">
                  <c:v>103.8115851364115</c:v>
                </c:pt>
                <c:pt idx="3">
                  <c:v>103.3347039714867</c:v>
                </c:pt>
                <c:pt idx="4">
                  <c:v>103.9747355044913</c:v>
                </c:pt>
                <c:pt idx="5">
                  <c:v>105.736828682694</c:v>
                </c:pt>
                <c:pt idx="6">
                  <c:v>106.8327661110033</c:v>
                </c:pt>
                <c:pt idx="7">
                  <c:v>107.1113958991937</c:v>
                </c:pt>
                <c:pt idx="8">
                  <c:v>108.929939278678</c:v>
                </c:pt>
                <c:pt idx="9">
                  <c:v>109.9367719640794</c:v>
                </c:pt>
                <c:pt idx="10">
                  <c:v>108.1674361777993</c:v>
                </c:pt>
                <c:pt idx="11">
                  <c:v>103.4765219680008</c:v>
                </c:pt>
                <c:pt idx="12">
                  <c:v>98.28423404252764</c:v>
                </c:pt>
                <c:pt idx="13">
                  <c:v>90.84305419495621</c:v>
                </c:pt>
                <c:pt idx="14">
                  <c:v>90.0597910468275</c:v>
                </c:pt>
                <c:pt idx="15">
                  <c:v>88.36512183153248</c:v>
                </c:pt>
                <c:pt idx="16">
                  <c:v>97.62961236817138</c:v>
                </c:pt>
                <c:pt idx="17">
                  <c:v>98.4348686410481</c:v>
                </c:pt>
                <c:pt idx="18">
                  <c:v>100.5244403590698</c:v>
                </c:pt>
                <c:pt idx="19">
                  <c:v>99.85056280960808</c:v>
                </c:pt>
                <c:pt idx="20">
                  <c:v>99.62654283344453</c:v>
                </c:pt>
                <c:pt idx="21">
                  <c:v>100.41754101624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48F-5645-B240-C2C9EC0F38DB}"/>
            </c:ext>
          </c:extLst>
        </c:ser>
        <c:ser>
          <c:idx val="2"/>
          <c:order val="2"/>
          <c:tx>
            <c:strRef>
              <c:f>Sheet1!$A$100</c:f>
              <c:strCache>
                <c:ptCount val="1"/>
                <c:pt idx="0">
                  <c:v>PRV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squar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104:$W$104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994990874814001</c:v>
                  </c:pt>
                  <c:pt idx="2">
                    <c:v>2.669636246459776</c:v>
                  </c:pt>
                  <c:pt idx="3">
                    <c:v>3.146204828826825</c:v>
                  </c:pt>
                  <c:pt idx="4">
                    <c:v>2.89150644995666</c:v>
                  </c:pt>
                  <c:pt idx="5">
                    <c:v>4.167010422057825</c:v>
                  </c:pt>
                  <c:pt idx="6">
                    <c:v>4.437585924446386</c:v>
                  </c:pt>
                  <c:pt idx="7">
                    <c:v>5.169089794724797</c:v>
                  </c:pt>
                  <c:pt idx="8">
                    <c:v>4.549789228855897</c:v>
                  </c:pt>
                  <c:pt idx="9">
                    <c:v>4.321488501705179</c:v>
                  </c:pt>
                  <c:pt idx="10">
                    <c:v>4.453011540288469</c:v>
                  </c:pt>
                  <c:pt idx="11">
                    <c:v>8.035044681642094</c:v>
                  </c:pt>
                  <c:pt idx="12">
                    <c:v>12.96753604150177</c:v>
                  </c:pt>
                  <c:pt idx="13">
                    <c:v>14.49050419509592</c:v>
                  </c:pt>
                  <c:pt idx="14">
                    <c:v>14.93597039648004</c:v>
                  </c:pt>
                  <c:pt idx="15">
                    <c:v>16.8058579972602</c:v>
                  </c:pt>
                  <c:pt idx="16">
                    <c:v>10.99682524045644</c:v>
                  </c:pt>
                  <c:pt idx="17">
                    <c:v>8.68242055308094</c:v>
                  </c:pt>
                  <c:pt idx="18">
                    <c:v>3.807330536671468</c:v>
                  </c:pt>
                  <c:pt idx="19">
                    <c:v>6.32215419416227</c:v>
                  </c:pt>
                  <c:pt idx="20">
                    <c:v>7.13736132492788</c:v>
                  </c:pt>
                  <c:pt idx="21">
                    <c:v>7.8889847666134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97:$W$97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100:$W$100</c:f>
              <c:numCache>
                <c:formatCode>General</c:formatCode>
                <c:ptCount val="22"/>
                <c:pt idx="0">
                  <c:v>100.0</c:v>
                </c:pt>
                <c:pt idx="1">
                  <c:v>103.7921094413312</c:v>
                </c:pt>
                <c:pt idx="2">
                  <c:v>104.1264103295567</c:v>
                </c:pt>
                <c:pt idx="3">
                  <c:v>105.5546317692292</c:v>
                </c:pt>
                <c:pt idx="4">
                  <c:v>106.1929607293967</c:v>
                </c:pt>
                <c:pt idx="5">
                  <c:v>108.3875201412251</c:v>
                </c:pt>
                <c:pt idx="6">
                  <c:v>109.5436217842564</c:v>
                </c:pt>
                <c:pt idx="7">
                  <c:v>110.9007887027783</c:v>
                </c:pt>
                <c:pt idx="8">
                  <c:v>112.2860211748592</c:v>
                </c:pt>
                <c:pt idx="9">
                  <c:v>112.3886781796901</c:v>
                </c:pt>
                <c:pt idx="10">
                  <c:v>113.0910606752781</c:v>
                </c:pt>
                <c:pt idx="11">
                  <c:v>110.8946125308889</c:v>
                </c:pt>
                <c:pt idx="12">
                  <c:v>105.5415965276239</c:v>
                </c:pt>
                <c:pt idx="13">
                  <c:v>100.2984822807784</c:v>
                </c:pt>
                <c:pt idx="14">
                  <c:v>99.71535433943795</c:v>
                </c:pt>
                <c:pt idx="15">
                  <c:v>96.80015929815174</c:v>
                </c:pt>
                <c:pt idx="16">
                  <c:v>101.2506443825287</c:v>
                </c:pt>
                <c:pt idx="17">
                  <c:v>97.51575350323971</c:v>
                </c:pt>
                <c:pt idx="18">
                  <c:v>96.73400002374306</c:v>
                </c:pt>
                <c:pt idx="19">
                  <c:v>95.63119335809013</c:v>
                </c:pt>
                <c:pt idx="20">
                  <c:v>98.95077243077904</c:v>
                </c:pt>
                <c:pt idx="21">
                  <c:v>100.23723470266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48F-5645-B240-C2C9EC0F38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93562000"/>
        <c:axId val="-2086544176"/>
      </c:lineChart>
      <c:catAx>
        <c:axId val="-2093562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ja-JP"/>
          </a:p>
        </c:txPr>
        <c:crossAx val="-2086544176"/>
        <c:crosses val="autoZero"/>
        <c:auto val="1"/>
        <c:lblAlgn val="ctr"/>
        <c:lblOffset val="100"/>
        <c:noMultiLvlLbl val="0"/>
      </c:catAx>
      <c:valAx>
        <c:axId val="-2086544176"/>
        <c:scaling>
          <c:orientation val="minMax"/>
          <c:max val="120.0"/>
          <c:min val="8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ja-JP"/>
          </a:p>
        </c:txPr>
        <c:crossAx val="-20935620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999E1D-F594-7D47-B0D0-FBEEAB6878A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5002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170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2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4422727"/>
              </p:ext>
            </p:extLst>
          </p:nvPr>
        </p:nvGraphicFramePr>
        <p:xfrm>
          <a:off x="428942" y="1207751"/>
          <a:ext cx="2776702" cy="1884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502343" y="2960937"/>
            <a:ext cx="2589104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739017" y="29003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958607" y="29003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1183892" y="29003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1409177" y="29003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1560427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1802958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2022709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242460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2462211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2727524" y="29003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04145" y="3092962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502342" y="289783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正方形/長方形 26"/>
          <p:cNvSpPr/>
          <p:nvPr/>
        </p:nvSpPr>
        <p:spPr>
          <a:xfrm rot="16200000">
            <a:off x="-658011" y="1798382"/>
            <a:ext cx="2031002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54579" y="276508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40372" y="245409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AC0C3899-0921-4F4C-93E7-1B96239CE567}"/>
              </a:ext>
            </a:extLst>
          </p:cNvPr>
          <p:cNvSpPr txBox="1"/>
          <p:nvPr/>
        </p:nvSpPr>
        <p:spPr>
          <a:xfrm>
            <a:off x="340372" y="210955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40372" y="177307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F4C64E0E-D4C1-7F4F-9D02-BDC788DDE822}"/>
              </a:ext>
            </a:extLst>
          </p:cNvPr>
          <p:cNvSpPr txBox="1"/>
          <p:nvPr/>
        </p:nvSpPr>
        <p:spPr>
          <a:xfrm>
            <a:off x="340372" y="111844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363278" y="1974829"/>
            <a:ext cx="1202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Clinical Score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35012" y="145092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8" name="テキスト ボックス 44"/>
          <p:cNvSpPr txBox="1">
            <a:spLocks noChangeArrowheads="1"/>
          </p:cNvSpPr>
          <p:nvPr/>
        </p:nvSpPr>
        <p:spPr bwMode="auto">
          <a:xfrm>
            <a:off x="58609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29" name="テキスト ボックス 44"/>
          <p:cNvSpPr txBox="1">
            <a:spLocks noChangeArrowheads="1"/>
          </p:cNvSpPr>
          <p:nvPr/>
        </p:nvSpPr>
        <p:spPr bwMode="auto">
          <a:xfrm>
            <a:off x="3486101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/>
                <a:cs typeface="Helvetica"/>
              </a:rPr>
              <a:t>B</a:t>
            </a:r>
            <a:endParaRPr lang="ja-JP" altLang="en-US" dirty="0">
              <a:latin typeface="Helvetica"/>
              <a:cs typeface="Helvetica"/>
            </a:endParaRPr>
          </a:p>
        </p:txBody>
      </p:sp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1375812"/>
              </p:ext>
            </p:extLst>
          </p:nvPr>
        </p:nvGraphicFramePr>
        <p:xfrm>
          <a:off x="3707747" y="1124595"/>
          <a:ext cx="2854908" cy="22467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1" name="正方形/長方形 30"/>
          <p:cNvSpPr/>
          <p:nvPr/>
        </p:nvSpPr>
        <p:spPr>
          <a:xfrm>
            <a:off x="3876052" y="2932031"/>
            <a:ext cx="262310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4146731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4354931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4546046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4782721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973836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5199282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5413338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633089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5869925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6135238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211859" y="3064056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3910056" y="286892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5" name="正方形/長方形 44"/>
          <p:cNvSpPr/>
          <p:nvPr/>
        </p:nvSpPr>
        <p:spPr>
          <a:xfrm rot="5400000">
            <a:off x="2787442" y="1910479"/>
            <a:ext cx="195375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674770" y="277537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665041" y="233683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9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 rot="16200000">
            <a:off x="2707526" y="2014699"/>
            <a:ext cx="163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% of original weight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86646" y="1909481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98406" y="1507751"/>
            <a:ext cx="433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95540" y="1096550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890405" y="1584233"/>
            <a:ext cx="890736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PRVABC59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877608" y="1371676"/>
            <a:ext cx="6187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050" b="1" dirty="0">
                <a:latin typeface="Helvetica"/>
                <a:ea typeface="Helvetica" charset="0"/>
                <a:cs typeface="Helvetica"/>
              </a:rPr>
              <a:t>M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R766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880709" y="1184999"/>
            <a:ext cx="543739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273661" y="2636294"/>
            <a:ext cx="890736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PRVABC59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260864" y="2423737"/>
            <a:ext cx="6187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050" b="1" dirty="0">
                <a:latin typeface="Helvetica"/>
                <a:ea typeface="Helvetica" charset="0"/>
                <a:cs typeface="Helvetica"/>
              </a:rPr>
              <a:t>M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R766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263965" y="2237060"/>
            <a:ext cx="543739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6" name="二等辺三角形 65"/>
          <p:cNvSpPr/>
          <p:nvPr/>
        </p:nvSpPr>
        <p:spPr>
          <a:xfrm>
            <a:off x="794089" y="1278648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67" name="円/楕円 66"/>
          <p:cNvSpPr/>
          <p:nvPr/>
        </p:nvSpPr>
        <p:spPr>
          <a:xfrm>
            <a:off x="794671" y="1474276"/>
            <a:ext cx="64355" cy="64349"/>
          </a:xfrm>
          <a:prstGeom prst="ellips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806061" y="1700165"/>
            <a:ext cx="55424" cy="47822"/>
          </a:xfrm>
          <a:prstGeom prst="rect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70" name="二等辺三角形 69"/>
          <p:cNvSpPr/>
          <p:nvPr/>
        </p:nvSpPr>
        <p:spPr>
          <a:xfrm>
            <a:off x="4165697" y="2330058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71" name="円/楕円 70"/>
          <p:cNvSpPr/>
          <p:nvPr/>
        </p:nvSpPr>
        <p:spPr>
          <a:xfrm>
            <a:off x="4158258" y="2525686"/>
            <a:ext cx="64355" cy="64349"/>
          </a:xfrm>
          <a:prstGeom prst="ellips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4161627" y="2751575"/>
            <a:ext cx="55424" cy="47822"/>
          </a:xfrm>
          <a:prstGeom prst="rect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315038" y="114833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cxnSp>
        <p:nvCxnSpPr>
          <p:cNvPr id="74" name="直線コネクタ 73"/>
          <p:cNvCxnSpPr/>
          <p:nvPr/>
        </p:nvCxnSpPr>
        <p:spPr>
          <a:xfrm flipV="1">
            <a:off x="1849961" y="1635273"/>
            <a:ext cx="1246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1793428" y="1470966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2047626" y="1046499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cxnSp>
        <p:nvCxnSpPr>
          <p:cNvPr id="84" name="直線コネクタ 83"/>
          <p:cNvCxnSpPr/>
          <p:nvPr/>
        </p:nvCxnSpPr>
        <p:spPr>
          <a:xfrm>
            <a:off x="2090814" y="122137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/>
          <p:cNvSpPr txBox="1"/>
          <p:nvPr/>
        </p:nvSpPr>
        <p:spPr>
          <a:xfrm>
            <a:off x="2378546" y="1369251"/>
            <a:ext cx="36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*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2541462" y="1271128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2677346" y="1201738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cxnSp>
        <p:nvCxnSpPr>
          <p:cNvPr id="88" name="直線コネクタ 87"/>
          <p:cNvCxnSpPr/>
          <p:nvPr/>
        </p:nvCxnSpPr>
        <p:spPr>
          <a:xfrm>
            <a:off x="2749010" y="1376614"/>
            <a:ext cx="15303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/>
          <p:cNvSpPr txBox="1"/>
          <p:nvPr/>
        </p:nvSpPr>
        <p:spPr>
          <a:xfrm>
            <a:off x="2878588" y="1452395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2535169" y="177329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FF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0000FF"/>
              </a:solidFill>
              <a:latin typeface="Helvetica"/>
              <a:cs typeface="Helvetica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2734296" y="188563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FF"/>
                </a:solidFill>
                <a:latin typeface="Helvetica"/>
                <a:cs typeface="Helvetica"/>
              </a:rPr>
              <a:t>**</a:t>
            </a:r>
            <a:endParaRPr lang="ja-JP" altLang="en-US" sz="1200" b="1" dirty="0">
              <a:solidFill>
                <a:srgbClr val="0000FF"/>
              </a:solidFill>
              <a:latin typeface="Helvetica"/>
              <a:cs typeface="Helvetica"/>
            </a:endParaRPr>
          </a:p>
        </p:txBody>
      </p:sp>
      <p:cxnSp>
        <p:nvCxnSpPr>
          <p:cNvPr id="92" name="直線コネクタ 91"/>
          <p:cNvCxnSpPr/>
          <p:nvPr/>
        </p:nvCxnSpPr>
        <p:spPr>
          <a:xfrm>
            <a:off x="2783382" y="195781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/>
          <p:cNvSpPr txBox="1"/>
          <p:nvPr/>
        </p:nvSpPr>
        <p:spPr>
          <a:xfrm>
            <a:off x="5308626" y="2671049"/>
            <a:ext cx="36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*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5491492" y="2732968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5561045" y="251365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814735" y="2220033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6175103" y="2285237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cxnSp>
        <p:nvCxnSpPr>
          <p:cNvPr id="98" name="直線コネクタ 97"/>
          <p:cNvCxnSpPr/>
          <p:nvPr/>
        </p:nvCxnSpPr>
        <p:spPr>
          <a:xfrm>
            <a:off x="6184324" y="235742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/>
          <p:cNvSpPr txBox="1"/>
          <p:nvPr/>
        </p:nvSpPr>
        <p:spPr>
          <a:xfrm>
            <a:off x="5931748" y="2005621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FF"/>
                </a:solidFill>
                <a:latin typeface="Helvetica"/>
                <a:cs typeface="Helvetica"/>
              </a:rPr>
              <a:t>*</a:t>
            </a:r>
            <a:endParaRPr lang="ja-JP" altLang="en-US" sz="1200" b="1" dirty="0">
              <a:solidFill>
                <a:srgbClr val="0000FF"/>
              </a:solidFill>
              <a:latin typeface="Helvetica"/>
              <a:cs typeface="Helvetica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6124255" y="177371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FF"/>
                </a:solidFill>
                <a:latin typeface="Helvetica"/>
                <a:cs typeface="Helvetica"/>
              </a:rPr>
              <a:t>**</a:t>
            </a:r>
            <a:endParaRPr lang="ja-JP" altLang="en-US" sz="1200" b="1" dirty="0">
              <a:solidFill>
                <a:srgbClr val="0000FF"/>
              </a:solidFill>
              <a:latin typeface="Helvetica"/>
              <a:cs typeface="Helvetica"/>
            </a:endParaRPr>
          </a:p>
        </p:txBody>
      </p:sp>
      <p:cxnSp>
        <p:nvCxnSpPr>
          <p:cNvPr id="101" name="直線コネクタ 100"/>
          <p:cNvCxnSpPr/>
          <p:nvPr/>
        </p:nvCxnSpPr>
        <p:spPr>
          <a:xfrm>
            <a:off x="6167443" y="194858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47145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Figure_Cell Host &amp; Microbe" id="{89AAFB5B-E625-2B4C-8409-65E986DCC102}" vid="{2076EB3B-70CE-B442-B468-6FD57409D673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Figure_International immunology FigureS2</Template>
  <TotalTime>0</TotalTime>
  <Words>76</Words>
  <Application>Microsoft Macintosh PowerPoint</Application>
  <PresentationFormat>画面に合わせる (4:3)</PresentationFormat>
  <Paragraphs>6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Calibri</vt:lpstr>
      <vt:lpstr>Helvetica</vt:lpstr>
      <vt:lpstr>ＭＳ Ｐゴシック</vt:lpstr>
      <vt:lpstr>Arial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神山長慶</dc:creator>
  <cp:keywords/>
  <dc:description/>
  <cp:lastModifiedBy>神山長慶</cp:lastModifiedBy>
  <cp:revision>1</cp:revision>
  <cp:lastPrinted>2024-05-22T05:30:17Z</cp:lastPrinted>
  <dcterms:created xsi:type="dcterms:W3CDTF">2025-05-01T06:23:15Z</dcterms:created>
  <dcterms:modified xsi:type="dcterms:W3CDTF">2025-05-01T06:23:59Z</dcterms:modified>
  <cp:category/>
</cp:coreProperties>
</file>